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9" autoAdjust="0"/>
    <p:restoredTop sz="94660"/>
  </p:normalViewPr>
  <p:slideViewPr>
    <p:cSldViewPr snapToGrid="0">
      <p:cViewPr varScale="1">
        <p:scale>
          <a:sx n="78" d="100"/>
          <a:sy n="78" d="100"/>
        </p:scale>
        <p:origin x="60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1CCB0C-115C-4A21-9E58-8CB6A4758F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DB7531-AAEC-4B81-9924-41FC33E95E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CB2695-9E71-4A9C-B870-C8B16CECA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C585C-2391-44A4-B6CD-5E457990A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6B8F9C-33B6-40AF-BB7A-68DE38462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455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1A360-9CC0-4573-8E10-CB56BDCC1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30C210-F5A0-430F-A7F9-39FF80510E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ABEECC-5CBC-42FB-BF84-B552F5C7D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24220D-4C28-41A7-9659-E45CADB5E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5963F-6E31-4413-B101-BA1143F39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3199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AE8551-2AD8-446C-9563-677B56F8C5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4F8F8E-AFB4-46BE-B508-7DD4574171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1F8965-5E76-4DD0-9F87-5EF1C9663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2BA41F-8118-4E2D-8767-1FDA5D536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E6DDE4-6DA5-49B0-ABF7-4D6EE0049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518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F3D82-487D-424B-8ED3-C91D4DB59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EB6198-860A-43D8-B644-93D94E2656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CC224-93B3-4848-B00E-EB5268C8A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1DDE17-A120-4945-AB14-295D966F0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D385EE-FA82-4BD2-B761-3074B8D4E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9473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79E125-16F2-4065-879B-201720307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5B8C15-AF05-40E3-9F53-05E0EE9B73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6D2CE4-6BE0-4ECB-AB29-6A5497FFF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7FA7D-A60A-4A31-A537-6490A3BF5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391B4A-25BD-43C5-9F65-F2B53FAB2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4417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A341CD-0A97-4B8C-B9F1-72FAF2FD3D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360926-E889-47D3-B942-350D881A8D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20F92C-F730-40DA-8766-9A3A741017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82770D-7A87-45B4-8CE3-CF37CD3D4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9936D0-5245-45A8-B136-81D2F99D8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301D35-DE1B-4CCE-8DDF-E9D1629B8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808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AE6F10-DAF9-4AD6-B080-71CED85D61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643096-2498-499D-9387-69D4F410F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197052-4E1F-481C-A90B-9973F938DA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297519-E7CA-4097-BF62-8FC862F92C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7AA976-0716-4AD3-B841-23AEDD9664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97683F-609B-4C1B-80AB-B72AB3266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F7120B-103B-4602-83BF-AD8DD18EC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A76A5B4-DA8F-4445-A139-58FD73C32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151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ADFB2B-69A0-420A-97F6-43EADE77FA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9DF5D5-E929-4E6F-A73E-CC7AB67E6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04760D-2750-43CE-BDDF-620936501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26BD12-8895-4448-88EF-1213734D2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4154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5A9536F-93C3-4C67-8657-0E43885E7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80A6C2-49E3-412D-BF35-74F1BD0EA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EADAE5-AAF4-490D-8129-C7E90FD1E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628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30D474-DB3D-4EC9-8355-355889A5A7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4D6240-0D45-48C1-9C5C-1C00BF0311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69774E-0FA6-4515-81FB-FDC024AE93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693FB5-763D-41B4-BABB-24D0C9F9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44379F-C638-40BD-B53A-7B89F677A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79F2DF-9CB8-4557-8E2D-29BC42354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3213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91486-6366-43FF-8998-CB948B3F4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0819A9-4867-44E2-B42A-231F0841AE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CC8AFE-5C08-4097-B662-CB33B5A2B6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483C21-966F-4D45-98E8-52C8C97A3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26FED0-FF09-4ACE-A02F-E44AF1F03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211EA9-B404-4719-B728-234DA6208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253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A60245-1C92-42D1-9217-5FB539604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9D8860-9860-4CCF-B586-732CD1E950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027D8-71ED-4896-865E-F984542475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40410-1E5E-43BC-B2C4-99D39E48D6F5}" type="datetimeFigureOut">
              <a:rPr lang="en-GB" smtClean="0"/>
              <a:t>31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5AE8CD-A75C-4A6F-8DC1-8C76FB5EC8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64A830-701E-4EA6-A0BE-006F52B317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341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7D82E01-03E6-449C-8986-0146399B34EF}"/>
              </a:ext>
            </a:extLst>
          </p:cNvPr>
          <p:cNvSpPr txBox="1"/>
          <p:nvPr/>
        </p:nvSpPr>
        <p:spPr>
          <a:xfrm>
            <a:off x="811033" y="302150"/>
            <a:ext cx="100663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l-SI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5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istance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chanisms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utative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istance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milies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dentified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ype</a:t>
            </a:r>
            <a:r>
              <a:rPr lang="sl-SI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rains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cetobacter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ecies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A) and </a:t>
            </a:r>
            <a:r>
              <a:rPr lang="sl-SI" sz="14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magataeibacter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ecies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B)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GB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A0A3E5-CBC8-418C-9DBB-4987D471FBD6}"/>
              </a:ext>
            </a:extLst>
          </p:cNvPr>
          <p:cNvSpPr txBox="1"/>
          <p:nvPr/>
        </p:nvSpPr>
        <p:spPr>
          <a:xfrm>
            <a:off x="993913" y="1105231"/>
            <a:ext cx="4452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l-SI" sz="1600" dirty="0"/>
              <a:t>A</a:t>
            </a:r>
            <a:endParaRPr lang="en-GB" sz="16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5AAC92B-B407-438C-AB6F-8D0669A24F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8373" y="1443785"/>
            <a:ext cx="9551670" cy="3676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5983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15C9865-0EBB-42B1-8734-41DCC7E41042}"/>
              </a:ext>
            </a:extLst>
          </p:cNvPr>
          <p:cNvSpPr txBox="1"/>
          <p:nvPr/>
        </p:nvSpPr>
        <p:spPr>
          <a:xfrm>
            <a:off x="778576" y="421689"/>
            <a:ext cx="4452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l-SI" sz="1600" dirty="0"/>
              <a:t>B</a:t>
            </a:r>
            <a:endParaRPr lang="en-GB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A3E3E1B-433C-4C54-8FDC-ECA40DDF50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5410" y="813191"/>
            <a:ext cx="9551670" cy="3676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9968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29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ja Trček</dc:creator>
  <cp:lastModifiedBy>Janja Trček</cp:lastModifiedBy>
  <cp:revision>7</cp:revision>
  <dcterms:created xsi:type="dcterms:W3CDTF">2021-12-26T16:36:24Z</dcterms:created>
  <dcterms:modified xsi:type="dcterms:W3CDTF">2021-12-31T22:32:23Z</dcterms:modified>
</cp:coreProperties>
</file>